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77" r:id="rId2"/>
    <p:sldId id="276" r:id="rId3"/>
    <p:sldId id="278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889" autoAdjust="0"/>
    <p:restoredTop sz="94715"/>
  </p:normalViewPr>
  <p:slideViewPr>
    <p:cSldViewPr snapToGrid="0">
      <p:cViewPr varScale="1">
        <p:scale>
          <a:sx n="41" d="100"/>
          <a:sy n="41" d="100"/>
        </p:scale>
        <p:origin x="2328" y="4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40E5BBC7-D6FA-4879-990A-421F381A4CD5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9440BF3-1429-40D0-8AC1-6467B31AC5AB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B1F13E-F67E-4412-BCB6-DBD69253C604}" type="datetimeFigureOut">
              <a:rPr lang="de-DE" smtClean="0"/>
              <a:t>11.06.2026</a:t>
            </a:fld>
            <a:endParaRPr lang="de-DE"/>
          </a:p>
        </p:txBody>
      </p:sp>
      <p:sp>
        <p:nvSpPr>
          <p:cNvPr id="4" name="Slide Image Placeholder 3">
            <a:extLst>
              <a:ext uri="{FF2B5EF4-FFF2-40B4-BE49-F238E27FC236}">
                <a16:creationId xmlns:a16="http://schemas.microsoft.com/office/drawing/2014/main" id="{D930660B-E3D3-4C3E-ACF3-A03C9CBFAFDD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es Placeholder 4">
            <a:extLst>
              <a:ext uri="{FF2B5EF4-FFF2-40B4-BE49-F238E27FC236}">
                <a16:creationId xmlns:a16="http://schemas.microsoft.com/office/drawing/2014/main" id="{6F546A06-2908-4976-873F-F12CAB5A33B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A6A9B9-860A-4B11-AC1A-42F56438CD5D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5F7528-6A87-4604-9B04-6AD7AAD932E2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352312-A507-4765-A0B2-B36F9EF94796}" type="slidenum">
              <a:rPr lang="de-DE" smtClean="0"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2EB5E-B54A-499F-AC7E-A50E29D941AC}" type="datetimeFigureOut">
              <a:rPr lang="de-DE" smtClean="0"/>
              <a:t>11.06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6EB8F-8668-4FCE-A071-3885CB3AC5D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71673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2EB5E-B54A-499F-AC7E-A50E29D941AC}" type="datetimeFigureOut">
              <a:rPr lang="de-DE" smtClean="0"/>
              <a:t>11.06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6EB8F-8668-4FCE-A071-3885CB3AC5D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884052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2EB5E-B54A-499F-AC7E-A50E29D941AC}" type="datetimeFigureOut">
              <a:rPr lang="de-DE" smtClean="0"/>
              <a:t>11.06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6EB8F-8668-4FCE-A071-3885CB3AC5D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49342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2EB5E-B54A-499F-AC7E-A50E29D941AC}" type="datetimeFigureOut">
              <a:rPr lang="de-DE" smtClean="0"/>
              <a:t>11.06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6EB8F-8668-4FCE-A071-3885CB3AC5D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357186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2EB5E-B54A-499F-AC7E-A50E29D941AC}" type="datetimeFigureOut">
              <a:rPr lang="de-DE" smtClean="0"/>
              <a:t>11.06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6EB8F-8668-4FCE-A071-3885CB3AC5D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243809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2EB5E-B54A-499F-AC7E-A50E29D941AC}" type="datetimeFigureOut">
              <a:rPr lang="de-DE" smtClean="0"/>
              <a:t>11.06.202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6EB8F-8668-4FCE-A071-3885CB3AC5D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135109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2EB5E-B54A-499F-AC7E-A50E29D941AC}" type="datetimeFigureOut">
              <a:rPr lang="de-DE" smtClean="0"/>
              <a:t>11.06.2026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6EB8F-8668-4FCE-A071-3885CB3AC5D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610801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2EB5E-B54A-499F-AC7E-A50E29D941AC}" type="datetimeFigureOut">
              <a:rPr lang="de-DE" smtClean="0"/>
              <a:t>11.06.2026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6EB8F-8668-4FCE-A071-3885CB3AC5D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481335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2EB5E-B54A-499F-AC7E-A50E29D941AC}" type="datetimeFigureOut">
              <a:rPr lang="de-DE" smtClean="0"/>
              <a:t>11.06.2026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6EB8F-8668-4FCE-A071-3885CB3AC5D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144553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2EB5E-B54A-499F-AC7E-A50E29D941AC}" type="datetimeFigureOut">
              <a:rPr lang="de-DE" smtClean="0"/>
              <a:t>11.06.202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6EB8F-8668-4FCE-A071-3885CB3AC5D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199822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2EB5E-B54A-499F-AC7E-A50E29D941AC}" type="datetimeFigureOut">
              <a:rPr lang="de-DE" smtClean="0"/>
              <a:t>11.06.202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6EB8F-8668-4FCE-A071-3885CB3AC5D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5515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42EB5E-B54A-499F-AC7E-A50E29D941AC}" type="datetimeFigureOut">
              <a:rPr lang="de-DE" smtClean="0"/>
              <a:t>11.06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E6EB8F-8668-4FCE-A071-3885CB3AC5D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89901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TextBox 49">
            <a:extLst>
              <a:ext uri="{FF2B5EF4-FFF2-40B4-BE49-F238E27FC236}">
                <a16:creationId xmlns:a16="http://schemas.microsoft.com/office/drawing/2014/main" id="{E2384617-1ADC-4E16-9C31-CA4876273ED4}"/>
              </a:ext>
            </a:extLst>
          </p:cNvPr>
          <p:cNvSpPr txBox="1"/>
          <p:nvPr/>
        </p:nvSpPr>
        <p:spPr>
          <a:xfrm flipH="1">
            <a:off x="126162" y="6383045"/>
            <a:ext cx="657097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MALDI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oF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MS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spectra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eacetylat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xylan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hydrolys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GH10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xylanas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  <a:p>
            <a:pPr algn="just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pectra are representative of three biological replicates. Structures were annotated according to the observed mass-to-charge ratio (m/z)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U,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GlcA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; X, xylose; Me, methyl. Masses are shown as sodium adducts. Labels are color-coded as follows: black, unsubstituted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xylooligosaccharides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; blue,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xylooligosaccharides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containing only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GlcA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residues; red,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xylooligosaccharides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containing only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MeGlcA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residues; and green,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xylooligosaccharides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containing both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GlcA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MeGlcA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residues.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6" name="Group 115">
            <a:extLst>
              <a:ext uri="{FF2B5EF4-FFF2-40B4-BE49-F238E27FC236}">
                <a16:creationId xmlns:a16="http://schemas.microsoft.com/office/drawing/2014/main" id="{306E1DEF-8954-4247-B7AA-931CBF11B302}"/>
              </a:ext>
            </a:extLst>
          </p:cNvPr>
          <p:cNvGrpSpPr/>
          <p:nvPr/>
        </p:nvGrpSpPr>
        <p:grpSpPr>
          <a:xfrm>
            <a:off x="74119" y="1545946"/>
            <a:ext cx="6547579" cy="4649925"/>
            <a:chOff x="71244" y="458544"/>
            <a:chExt cx="6547579" cy="4649925"/>
          </a:xfrm>
        </p:grpSpPr>
        <p:grpSp>
          <p:nvGrpSpPr>
            <p:cNvPr id="76" name="Group 75">
              <a:extLst>
                <a:ext uri="{FF2B5EF4-FFF2-40B4-BE49-F238E27FC236}">
                  <a16:creationId xmlns:a16="http://schemas.microsoft.com/office/drawing/2014/main" id="{5D023572-62F8-40E8-8C7A-102DE8A9B8E7}"/>
                </a:ext>
              </a:extLst>
            </p:cNvPr>
            <p:cNvGrpSpPr/>
            <p:nvPr/>
          </p:nvGrpSpPr>
          <p:grpSpPr>
            <a:xfrm>
              <a:off x="71244" y="1087908"/>
              <a:ext cx="6547579" cy="4020561"/>
              <a:chOff x="71244" y="741398"/>
              <a:chExt cx="6547579" cy="4020561"/>
            </a:xfrm>
          </p:grpSpPr>
          <p:pic>
            <p:nvPicPr>
              <p:cNvPr id="48" name="Picture 47">
                <a:extLst>
                  <a:ext uri="{FF2B5EF4-FFF2-40B4-BE49-F238E27FC236}">
                    <a16:creationId xmlns:a16="http://schemas.microsoft.com/office/drawing/2014/main" id="{DBB983A0-AB44-48F4-AC60-948257AA3A2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766" t="3009" r="1497" b="6573"/>
              <a:stretch/>
            </p:blipFill>
            <p:spPr>
              <a:xfrm>
                <a:off x="359458" y="741398"/>
                <a:ext cx="5262702" cy="3421064"/>
              </a:xfrm>
              <a:prstGeom prst="rect">
                <a:avLst/>
              </a:prstGeom>
            </p:spPr>
          </p:pic>
          <p:pic>
            <p:nvPicPr>
              <p:cNvPr id="39" name="Picture 38">
                <a:extLst>
                  <a:ext uri="{FF2B5EF4-FFF2-40B4-BE49-F238E27FC236}">
                    <a16:creationId xmlns:a16="http://schemas.microsoft.com/office/drawing/2014/main" id="{E957AE6D-A23A-4F66-8383-E1C7E2D338F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730" t="82555" r="1523" b="7906"/>
              <a:stretch/>
            </p:blipFill>
            <p:spPr>
              <a:xfrm>
                <a:off x="359458" y="4176749"/>
                <a:ext cx="5271774" cy="369766"/>
              </a:xfrm>
              <a:prstGeom prst="rect">
                <a:avLst/>
              </a:prstGeom>
            </p:spPr>
          </p:pic>
          <p:cxnSp>
            <p:nvCxnSpPr>
              <p:cNvPr id="51" name="Straight Connector 50">
                <a:extLst>
                  <a:ext uri="{FF2B5EF4-FFF2-40B4-BE49-F238E27FC236}">
                    <a16:creationId xmlns:a16="http://schemas.microsoft.com/office/drawing/2014/main" id="{4450CA7D-B853-42C3-B825-17FA1048944F}"/>
                  </a:ext>
                </a:extLst>
              </p:cNvPr>
              <p:cNvCxnSpPr/>
              <p:nvPr/>
            </p:nvCxnSpPr>
            <p:spPr>
              <a:xfrm>
                <a:off x="353108" y="774747"/>
                <a:ext cx="0" cy="374400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Straight Connector 51">
                <a:extLst>
                  <a:ext uri="{FF2B5EF4-FFF2-40B4-BE49-F238E27FC236}">
                    <a16:creationId xmlns:a16="http://schemas.microsoft.com/office/drawing/2014/main" id="{6EFDC1F2-BC65-42A7-9BA5-9F70AFCBCA6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53108" y="4517843"/>
                <a:ext cx="5292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24132B38-BB46-4611-8CA3-5D7CFCF6334A}"/>
                  </a:ext>
                </a:extLst>
              </p:cNvPr>
              <p:cNvSpPr txBox="1"/>
              <p:nvPr/>
            </p:nvSpPr>
            <p:spPr>
              <a:xfrm rot="16200000">
                <a:off x="-422962" y="2523636"/>
                <a:ext cx="123463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de-DE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ntensity</a:t>
                </a:r>
                <a:endParaRPr lang="de-DE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036670D9-8491-4779-A175-F097F444D60B}"/>
                  </a:ext>
                </a:extLst>
              </p:cNvPr>
              <p:cNvSpPr txBox="1"/>
              <p:nvPr/>
            </p:nvSpPr>
            <p:spPr>
              <a:xfrm>
                <a:off x="1883886" y="4546515"/>
                <a:ext cx="42524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0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6E67384B-6121-4B4F-B207-BEF5BEE756B1}"/>
                  </a:ext>
                </a:extLst>
              </p:cNvPr>
              <p:cNvSpPr txBox="1"/>
              <p:nvPr/>
            </p:nvSpPr>
            <p:spPr>
              <a:xfrm>
                <a:off x="2490090" y="4546515"/>
                <a:ext cx="42524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100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98A5B52E-4538-4336-B17B-0729A427EBA2}"/>
                  </a:ext>
                </a:extLst>
              </p:cNvPr>
              <p:cNvSpPr txBox="1"/>
              <p:nvPr/>
            </p:nvSpPr>
            <p:spPr>
              <a:xfrm>
                <a:off x="3071108" y="4546515"/>
                <a:ext cx="42524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200</a:t>
                </a: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253F06D4-ADDE-4844-8852-B8B2477E9CF0}"/>
                  </a:ext>
                </a:extLst>
              </p:cNvPr>
              <p:cNvSpPr txBox="1"/>
              <p:nvPr/>
            </p:nvSpPr>
            <p:spPr>
              <a:xfrm>
                <a:off x="3652126" y="4546515"/>
                <a:ext cx="42524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300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323227C3-B2FB-4F99-B67F-508C7A68FE90}"/>
                  </a:ext>
                </a:extLst>
              </p:cNvPr>
              <p:cNvSpPr txBox="1"/>
              <p:nvPr/>
            </p:nvSpPr>
            <p:spPr>
              <a:xfrm>
                <a:off x="1329903" y="4546515"/>
                <a:ext cx="42524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900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61856581-2049-4956-B4A1-E014BA7194C8}"/>
                  </a:ext>
                </a:extLst>
              </p:cNvPr>
              <p:cNvSpPr txBox="1"/>
              <p:nvPr/>
            </p:nvSpPr>
            <p:spPr>
              <a:xfrm>
                <a:off x="775920" y="4546515"/>
                <a:ext cx="42524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00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86A84A14-65D6-402E-8906-6617667C16A2}"/>
                  </a:ext>
                </a:extLst>
              </p:cNvPr>
              <p:cNvSpPr txBox="1"/>
              <p:nvPr/>
            </p:nvSpPr>
            <p:spPr>
              <a:xfrm>
                <a:off x="4233144" y="4546515"/>
                <a:ext cx="42524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400</a:t>
                </a: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3669DEA9-22CD-44F3-BC0B-EF4B44D9CC2D}"/>
                  </a:ext>
                </a:extLst>
              </p:cNvPr>
              <p:cNvSpPr txBox="1"/>
              <p:nvPr/>
            </p:nvSpPr>
            <p:spPr>
              <a:xfrm>
                <a:off x="4814162" y="4546515"/>
                <a:ext cx="42524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00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57BF80D1-9B26-490E-9526-B2D898F10480}"/>
                  </a:ext>
                </a:extLst>
              </p:cNvPr>
              <p:cNvSpPr txBox="1"/>
              <p:nvPr/>
            </p:nvSpPr>
            <p:spPr>
              <a:xfrm>
                <a:off x="221937" y="4546515"/>
                <a:ext cx="42524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00</a:t>
                </a: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5D8D3E7D-4515-4607-8111-D3455BCB804E}"/>
                  </a:ext>
                </a:extLst>
              </p:cNvPr>
              <p:cNvSpPr txBox="1"/>
              <p:nvPr/>
            </p:nvSpPr>
            <p:spPr>
              <a:xfrm>
                <a:off x="5390036" y="4546515"/>
                <a:ext cx="42524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600</a:t>
                </a: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C44B9793-F40C-4335-BF85-F137FF998F3D}"/>
                  </a:ext>
                </a:extLst>
              </p:cNvPr>
              <p:cNvSpPr txBox="1"/>
              <p:nvPr/>
            </p:nvSpPr>
            <p:spPr>
              <a:xfrm>
                <a:off x="5607008" y="922141"/>
                <a:ext cx="4411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l-0</a:t>
                </a: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75408D6E-E81E-4EDD-97A0-59CD52A9DDF5}"/>
                  </a:ext>
                </a:extLst>
              </p:cNvPr>
              <p:cNvSpPr txBox="1"/>
              <p:nvPr/>
            </p:nvSpPr>
            <p:spPr>
              <a:xfrm>
                <a:off x="5607008" y="1270089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tbl29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7D9C327C-7E63-4586-A52B-F22FFBAE682D}"/>
                  </a:ext>
                </a:extLst>
              </p:cNvPr>
              <p:cNvSpPr txBox="1"/>
              <p:nvPr/>
            </p:nvSpPr>
            <p:spPr>
              <a:xfrm>
                <a:off x="5607008" y="1601217"/>
                <a:ext cx="4491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ax3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91530A08-425C-4EED-8CC4-EBB09AC6D537}"/>
                  </a:ext>
                </a:extLst>
              </p:cNvPr>
              <p:cNvSpPr txBox="1"/>
              <p:nvPr/>
            </p:nvSpPr>
            <p:spPr>
              <a:xfrm>
                <a:off x="5607008" y="1944492"/>
                <a:ext cx="71846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tbl29 max3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860EE761-DFE4-4ED1-819E-7ADD9EDCAE45}"/>
                  </a:ext>
                </a:extLst>
              </p:cNvPr>
              <p:cNvSpPr txBox="1"/>
              <p:nvPr/>
            </p:nvSpPr>
            <p:spPr>
              <a:xfrm>
                <a:off x="5607008" y="3307145"/>
                <a:ext cx="4491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yc2</a:t>
                </a: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0DADFBC4-BEB0-4DB9-87CE-E40AD7DBE725}"/>
                  </a:ext>
                </a:extLst>
              </p:cNvPr>
              <p:cNvSpPr txBox="1"/>
              <p:nvPr/>
            </p:nvSpPr>
            <p:spPr>
              <a:xfrm>
                <a:off x="5607008" y="4350062"/>
                <a:ext cx="101181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tbl29 max3 myc2</a:t>
                </a:r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E8937387-74ED-48DF-A610-8E6727FF6097}"/>
                  </a:ext>
                </a:extLst>
              </p:cNvPr>
              <p:cNvSpPr txBox="1"/>
              <p:nvPr/>
            </p:nvSpPr>
            <p:spPr>
              <a:xfrm>
                <a:off x="5607008" y="3643355"/>
                <a:ext cx="71846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tbl29 myc2</a:t>
                </a: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61C78805-8734-499D-B84D-43A754471D20}"/>
                  </a:ext>
                </a:extLst>
              </p:cNvPr>
              <p:cNvSpPr txBox="1"/>
              <p:nvPr/>
            </p:nvSpPr>
            <p:spPr>
              <a:xfrm>
                <a:off x="5607008" y="3986221"/>
                <a:ext cx="74251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ax3 myc2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C1B1F9AB-46B9-46FC-9B47-EDA5DE518CF0}"/>
                  </a:ext>
                </a:extLst>
              </p:cNvPr>
              <p:cNvSpPr txBox="1"/>
              <p:nvPr/>
            </p:nvSpPr>
            <p:spPr>
              <a:xfrm>
                <a:off x="5752042" y="4537236"/>
                <a:ext cx="39052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/z</a:t>
                </a: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D35AF4ED-0990-488A-AE91-2A32207D7FF4}"/>
                  </a:ext>
                </a:extLst>
              </p:cNvPr>
              <p:cNvSpPr txBox="1"/>
              <p:nvPr/>
            </p:nvSpPr>
            <p:spPr>
              <a:xfrm>
                <a:off x="5607008" y="2270314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de-DE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ux1</a:t>
                </a: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620F9C26-1625-4512-8DD9-CC6CC10A665D}"/>
                  </a:ext>
                </a:extLst>
              </p:cNvPr>
              <p:cNvSpPr txBox="1"/>
              <p:nvPr/>
            </p:nvSpPr>
            <p:spPr>
              <a:xfrm>
                <a:off x="5607008" y="2619564"/>
                <a:ext cx="71846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ax3 g</a:t>
                </a:r>
                <a:r>
                  <a:rPr lang="de-DE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ux1</a:t>
                </a: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F93C81B7-1D4D-4CC8-977F-410B53FE3B00}"/>
                  </a:ext>
                </a:extLst>
              </p:cNvPr>
              <p:cNvSpPr txBox="1"/>
              <p:nvPr/>
            </p:nvSpPr>
            <p:spPr>
              <a:xfrm>
                <a:off x="5607008" y="2965004"/>
                <a:ext cx="92204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tbl29</a:t>
                </a:r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:</a:t>
                </a:r>
                <a:r>
                  <a:rPr lang="de-DE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GUX1-OE</a:t>
                </a:r>
              </a:p>
            </p:txBody>
          </p:sp>
        </p:grpSp>
        <p:grpSp>
          <p:nvGrpSpPr>
            <p:cNvPr id="77" name="Group 76">
              <a:extLst>
                <a:ext uri="{FF2B5EF4-FFF2-40B4-BE49-F238E27FC236}">
                  <a16:creationId xmlns:a16="http://schemas.microsoft.com/office/drawing/2014/main" id="{57ED99A7-89DD-4ED8-A105-BBC5EA0EE313}"/>
                </a:ext>
              </a:extLst>
            </p:cNvPr>
            <p:cNvGrpSpPr/>
            <p:nvPr/>
          </p:nvGrpSpPr>
          <p:grpSpPr>
            <a:xfrm>
              <a:off x="2276781" y="458544"/>
              <a:ext cx="410701" cy="805484"/>
              <a:chOff x="813031" y="1838811"/>
              <a:chExt cx="410701" cy="805484"/>
            </a:xfrm>
          </p:grpSpPr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09E067C0-C208-4766-B1F8-084E8E194447}"/>
                  </a:ext>
                </a:extLst>
              </p:cNvPr>
              <p:cNvSpPr txBox="1"/>
              <p:nvPr/>
            </p:nvSpPr>
            <p:spPr>
              <a:xfrm rot="16200000">
                <a:off x="588771" y="2202365"/>
                <a:ext cx="6639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53 </a:t>
                </a:r>
                <a:r>
                  <a:rPr lang="de-DE" sz="800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</a:t>
                </a:r>
                <a:r>
                  <a:rPr lang="de-DE" sz="800" baseline="-25000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de-DE" sz="800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  <a:r>
                  <a:rPr lang="de-DE" sz="800" baseline="-25000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de-D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8B4CEDDE-CB04-4819-A510-1A3E5BE996D5}"/>
                  </a:ext>
                </a:extLst>
              </p:cNvPr>
              <p:cNvSpPr txBox="1"/>
              <p:nvPr/>
            </p:nvSpPr>
            <p:spPr>
              <a:xfrm rot="16200000">
                <a:off x="625973" y="2138868"/>
                <a:ext cx="79541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67 </a:t>
                </a:r>
                <a:r>
                  <a:rPr lang="de-DE" sz="800" baseline="30000" dirty="0">
                    <a:solidFill>
                      <a:schemeClr val="accent6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</a:t>
                </a:r>
                <a:r>
                  <a:rPr lang="de-DE" sz="800" dirty="0">
                    <a:solidFill>
                      <a:schemeClr val="accent6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X</a:t>
                </a:r>
                <a:r>
                  <a:rPr lang="de-DE" sz="800" baseline="-25000" dirty="0">
                    <a:solidFill>
                      <a:schemeClr val="accent6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r>
                  <a:rPr lang="de-DE" sz="800" dirty="0">
                    <a:solidFill>
                      <a:schemeClr val="accent6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</a:t>
                </a:r>
                <a:endParaRPr lang="de-DE" sz="800" baseline="30000" dirty="0">
                  <a:solidFill>
                    <a:schemeClr val="accent6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BECD229E-8534-4874-8B58-D0BE8DB0FE8D}"/>
                  </a:ext>
                </a:extLst>
              </p:cNvPr>
              <p:cNvSpPr txBox="1"/>
              <p:nvPr/>
            </p:nvSpPr>
            <p:spPr>
              <a:xfrm rot="16200000">
                <a:off x="716701" y="2130398"/>
                <a:ext cx="79861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81</a:t>
                </a:r>
                <a:r>
                  <a:rPr lang="de-DE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800" baseline="30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</a:t>
                </a:r>
                <a:r>
                  <a:rPr lang="de-DE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</a:t>
                </a:r>
                <a:r>
                  <a:rPr lang="de-DE" sz="800" baseline="-25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de-DE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  <a:r>
                  <a:rPr lang="de-DE" sz="800" baseline="-25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de-D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1" name="Group 80">
              <a:extLst>
                <a:ext uri="{FF2B5EF4-FFF2-40B4-BE49-F238E27FC236}">
                  <a16:creationId xmlns:a16="http://schemas.microsoft.com/office/drawing/2014/main" id="{B6E1D350-CFD6-48DA-9081-BEEEBD8938C2}"/>
                </a:ext>
              </a:extLst>
            </p:cNvPr>
            <p:cNvGrpSpPr/>
            <p:nvPr/>
          </p:nvGrpSpPr>
          <p:grpSpPr>
            <a:xfrm>
              <a:off x="2808307" y="608458"/>
              <a:ext cx="309555" cy="724382"/>
              <a:chOff x="928653" y="1949251"/>
              <a:chExt cx="309555" cy="724382"/>
            </a:xfrm>
          </p:grpSpPr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DD64BDBC-60BF-4965-8094-46188A78FD64}"/>
                  </a:ext>
                </a:extLst>
              </p:cNvPr>
              <p:cNvSpPr txBox="1"/>
              <p:nvPr/>
            </p:nvSpPr>
            <p:spPr>
              <a:xfrm rot="16200000">
                <a:off x="723629" y="2253165"/>
                <a:ext cx="62549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141</a:t>
                </a:r>
                <a:r>
                  <a:rPr lang="de-DE" sz="800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UX</a:t>
                </a:r>
                <a:r>
                  <a:rPr lang="de-DE" sz="800" baseline="-25000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lang="de-D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972E44DD-6F0E-4311-A68D-A1C7B6F7AEDB}"/>
                  </a:ext>
                </a:extLst>
              </p:cNvPr>
              <p:cNvSpPr txBox="1"/>
              <p:nvPr/>
            </p:nvSpPr>
            <p:spPr>
              <a:xfrm rot="16200000">
                <a:off x="769650" y="2202365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155 </a:t>
                </a:r>
                <a:r>
                  <a:rPr lang="de-DE" sz="800" baseline="30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</a:t>
                </a:r>
                <a:r>
                  <a:rPr lang="de-DE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X</a:t>
                </a:r>
                <a:r>
                  <a:rPr lang="de-DE" sz="800" baseline="-25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lang="de-D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4C387CED-96A9-4935-B49C-4E460B60B89F}"/>
                </a:ext>
              </a:extLst>
            </p:cNvPr>
            <p:cNvSpPr txBox="1"/>
            <p:nvPr/>
          </p:nvSpPr>
          <p:spPr>
            <a:xfrm rot="16200000">
              <a:off x="2832145" y="1021062"/>
              <a:ext cx="6639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1185 </a:t>
              </a:r>
              <a:r>
                <a:rPr lang="de-DE" sz="8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</a:t>
              </a:r>
              <a:r>
                <a:rPr lang="de-DE" sz="800" baseline="-250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de-DE" sz="8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  <a:r>
                <a:rPr lang="de-DE" sz="800" baseline="-250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59F5F539-CFEF-41EE-8E86-035315ED55B4}"/>
                </a:ext>
              </a:extLst>
            </p:cNvPr>
            <p:cNvSpPr txBox="1"/>
            <p:nvPr/>
          </p:nvSpPr>
          <p:spPr>
            <a:xfrm rot="16200000">
              <a:off x="2851819" y="944862"/>
              <a:ext cx="82426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1199 </a:t>
              </a:r>
              <a:r>
                <a:rPr lang="de-DE" sz="800" baseline="30000" dirty="0">
                  <a:solidFill>
                    <a:schemeClr val="accent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</a:t>
              </a:r>
              <a:r>
                <a:rPr lang="de-DE" sz="800" dirty="0">
                  <a:solidFill>
                    <a:schemeClr val="accent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X</a:t>
              </a:r>
              <a:r>
                <a:rPr lang="de-DE" sz="800" baseline="-25000" dirty="0">
                  <a:solidFill>
                    <a:schemeClr val="accent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de-DE" sz="800" dirty="0">
                  <a:solidFill>
                    <a:schemeClr val="accent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B2F7231D-AB7C-4CCA-A0BD-034E50A9170F}"/>
                </a:ext>
              </a:extLst>
            </p:cNvPr>
            <p:cNvSpPr txBox="1"/>
            <p:nvPr/>
          </p:nvSpPr>
          <p:spPr>
            <a:xfrm rot="16200000">
              <a:off x="2978624" y="975342"/>
              <a:ext cx="7601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1213 </a:t>
              </a:r>
              <a:r>
                <a:rPr lang="de-DE" sz="800" baseline="30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</a:t>
              </a:r>
              <a:r>
                <a:rPr lang="de-DE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</a:t>
              </a:r>
              <a:r>
                <a:rPr lang="de-DE" sz="800" baseline="-25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de-DE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  <a:r>
                <a:rPr lang="de-DE" sz="800" baseline="-25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9" name="Group 88">
              <a:extLst>
                <a:ext uri="{FF2B5EF4-FFF2-40B4-BE49-F238E27FC236}">
                  <a16:creationId xmlns:a16="http://schemas.microsoft.com/office/drawing/2014/main" id="{757BB360-CEB7-4148-A01B-2D789C59F051}"/>
                </a:ext>
              </a:extLst>
            </p:cNvPr>
            <p:cNvGrpSpPr/>
            <p:nvPr/>
          </p:nvGrpSpPr>
          <p:grpSpPr>
            <a:xfrm>
              <a:off x="3566510" y="704785"/>
              <a:ext cx="311071" cy="761048"/>
              <a:chOff x="928652" y="1941299"/>
              <a:chExt cx="311071" cy="761048"/>
            </a:xfrm>
          </p:grpSpPr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C4FAF3A7-6823-4BA2-AE21-F764F038A3CF}"/>
                  </a:ext>
                </a:extLst>
              </p:cNvPr>
              <p:cNvSpPr txBox="1"/>
              <p:nvPr/>
            </p:nvSpPr>
            <p:spPr>
              <a:xfrm rot="16200000">
                <a:off x="723628" y="2281879"/>
                <a:ext cx="62549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273 </a:t>
                </a:r>
                <a:r>
                  <a:rPr lang="de-DE" sz="800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X</a:t>
                </a:r>
                <a:r>
                  <a:rPr lang="de-DE" sz="800" baseline="-25000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lang="de-D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1FCC3333-D3E1-4308-8418-ABB562A9D156}"/>
                  </a:ext>
                </a:extLst>
              </p:cNvPr>
              <p:cNvSpPr txBox="1"/>
              <p:nvPr/>
            </p:nvSpPr>
            <p:spPr>
              <a:xfrm rot="16200000">
                <a:off x="771165" y="2194413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287 </a:t>
                </a:r>
                <a:r>
                  <a:rPr lang="de-DE" sz="800" baseline="30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</a:t>
                </a:r>
                <a:r>
                  <a:rPr lang="de-DE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X</a:t>
                </a:r>
                <a:r>
                  <a:rPr lang="de-DE" sz="800" baseline="-25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lang="de-D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756EE79D-1892-4C7D-A662-1180F20ACF4C}"/>
                </a:ext>
              </a:extLst>
            </p:cNvPr>
            <p:cNvSpPr txBox="1"/>
            <p:nvPr/>
          </p:nvSpPr>
          <p:spPr>
            <a:xfrm rot="16200000">
              <a:off x="1898779" y="972867"/>
              <a:ext cx="7120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1023</a:t>
              </a:r>
              <a:r>
                <a:rPr lang="de-DE" sz="800" baseline="30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Me</a:t>
              </a:r>
              <a:r>
                <a:rPr lang="de-DE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X</a:t>
              </a:r>
              <a:r>
                <a:rPr lang="de-DE" sz="800" baseline="-25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93" name="Group 92">
              <a:extLst>
                <a:ext uri="{FF2B5EF4-FFF2-40B4-BE49-F238E27FC236}">
                  <a16:creationId xmlns:a16="http://schemas.microsoft.com/office/drawing/2014/main" id="{A1FABD8B-268F-4C4D-B67B-C8C50C1F4C9C}"/>
                </a:ext>
              </a:extLst>
            </p:cNvPr>
            <p:cNvGrpSpPr/>
            <p:nvPr/>
          </p:nvGrpSpPr>
          <p:grpSpPr>
            <a:xfrm>
              <a:off x="4333588" y="723837"/>
              <a:ext cx="323536" cy="758832"/>
              <a:chOff x="928653" y="1965155"/>
              <a:chExt cx="323536" cy="758832"/>
            </a:xfrm>
          </p:grpSpPr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1FBC29BD-0362-4B14-AABF-2FA2E4D15633}"/>
                  </a:ext>
                </a:extLst>
              </p:cNvPr>
              <p:cNvSpPr txBox="1"/>
              <p:nvPr/>
            </p:nvSpPr>
            <p:spPr>
              <a:xfrm rot="16200000">
                <a:off x="723629" y="2303519"/>
                <a:ext cx="62549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405 </a:t>
                </a:r>
                <a:r>
                  <a:rPr lang="de-DE" sz="800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X</a:t>
                </a:r>
                <a:r>
                  <a:rPr lang="de-DE" sz="800" baseline="-25000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  <a:endParaRPr lang="de-D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93EDA01D-1A3D-42F4-A1EF-3142DDB5CC2C}"/>
                  </a:ext>
                </a:extLst>
              </p:cNvPr>
              <p:cNvSpPr txBox="1"/>
              <p:nvPr/>
            </p:nvSpPr>
            <p:spPr>
              <a:xfrm rot="16200000">
                <a:off x="783631" y="2218269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419 </a:t>
                </a:r>
                <a:r>
                  <a:rPr lang="de-DE" sz="800" baseline="30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</a:t>
                </a:r>
                <a:r>
                  <a:rPr lang="de-DE" sz="8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X</a:t>
                </a:r>
                <a:r>
                  <a:rPr lang="de-DE" sz="800" baseline="-25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  <a:endParaRPr lang="de-D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3CC3C823-DFF0-48C6-860A-DF6FA1982C5A}"/>
                </a:ext>
              </a:extLst>
            </p:cNvPr>
            <p:cNvSpPr txBox="1"/>
            <p:nvPr/>
          </p:nvSpPr>
          <p:spPr>
            <a:xfrm rot="16200000">
              <a:off x="4875516" y="1046051"/>
              <a:ext cx="6639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1537 </a:t>
              </a:r>
              <a:r>
                <a:rPr lang="de-DE" sz="8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X</a:t>
              </a:r>
              <a:r>
                <a:rPr lang="de-DE" sz="800" baseline="-250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de-DE" sz="8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92B78292-A1EE-4C21-9757-C3A098F1CD07}"/>
                </a:ext>
              </a:extLst>
            </p:cNvPr>
            <p:cNvSpPr txBox="1"/>
            <p:nvPr/>
          </p:nvSpPr>
          <p:spPr>
            <a:xfrm rot="16200000">
              <a:off x="4933959" y="979557"/>
              <a:ext cx="7601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1551 </a:t>
              </a:r>
              <a:r>
                <a:rPr lang="de-DE" sz="800" baseline="30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</a:t>
              </a:r>
              <a:r>
                <a:rPr lang="de-DE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X</a:t>
              </a:r>
              <a:r>
                <a:rPr lang="de-DE" sz="800" baseline="-25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A60E7F39-8178-468C-BC49-090ACEC586BC}"/>
                </a:ext>
              </a:extLst>
            </p:cNvPr>
            <p:cNvSpPr txBox="1"/>
            <p:nvPr/>
          </p:nvSpPr>
          <p:spPr>
            <a:xfrm rot="16200000">
              <a:off x="1845103" y="1067039"/>
              <a:ext cx="6158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1009</a:t>
              </a:r>
              <a:r>
                <a:rPr lang="de-DE" sz="800" baseline="30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8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X</a:t>
              </a:r>
              <a:r>
                <a:rPr lang="de-DE" sz="800" baseline="-250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de-DE" sz="8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8D2C9984-16B5-450E-B3C7-4421E00ABF08}"/>
                </a:ext>
              </a:extLst>
            </p:cNvPr>
            <p:cNvSpPr txBox="1"/>
            <p:nvPr/>
          </p:nvSpPr>
          <p:spPr>
            <a:xfrm rot="16200000">
              <a:off x="1148308" y="996723"/>
              <a:ext cx="6543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891</a:t>
              </a:r>
              <a:r>
                <a:rPr lang="de-DE" sz="800" baseline="30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Me</a:t>
              </a:r>
              <a:r>
                <a:rPr lang="de-DE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X</a:t>
              </a:r>
              <a:r>
                <a:rPr lang="de-DE" sz="800" baseline="-25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2194E2CF-E6EC-48B2-925A-CF71649B7DDA}"/>
                </a:ext>
              </a:extLst>
            </p:cNvPr>
            <p:cNvSpPr txBox="1"/>
            <p:nvPr/>
          </p:nvSpPr>
          <p:spPr>
            <a:xfrm rot="16200000">
              <a:off x="904171" y="1107019"/>
              <a:ext cx="48442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833</a:t>
              </a:r>
              <a:r>
                <a:rPr lang="de-DE" sz="800" baseline="30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  <a:r>
                <a:rPr lang="de-DE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6D3638F9-A57C-4B2F-915B-B498238D25E8}"/>
                </a:ext>
              </a:extLst>
            </p:cNvPr>
            <p:cNvSpPr txBox="1"/>
            <p:nvPr/>
          </p:nvSpPr>
          <p:spPr>
            <a:xfrm rot="16200000">
              <a:off x="1648304" y="1108146"/>
              <a:ext cx="5132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965 X</a:t>
              </a:r>
              <a:r>
                <a:rPr lang="de-DE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614C345C-B0BA-49BD-AECB-8F1123A38325}"/>
                </a:ext>
              </a:extLst>
            </p:cNvPr>
            <p:cNvSpPr txBox="1"/>
            <p:nvPr/>
          </p:nvSpPr>
          <p:spPr>
            <a:xfrm rot="16200000">
              <a:off x="4667073" y="1090899"/>
              <a:ext cx="5902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1493 X</a:t>
              </a:r>
              <a:r>
                <a:rPr lang="de-DE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B9CB9EF1-FC8D-443B-9B1F-55EEC0E19A6E}"/>
                </a:ext>
              </a:extLst>
            </p:cNvPr>
            <p:cNvSpPr txBox="1"/>
            <p:nvPr/>
          </p:nvSpPr>
          <p:spPr>
            <a:xfrm rot="16200000">
              <a:off x="3901479" y="1090899"/>
              <a:ext cx="5902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1361 X</a:t>
              </a:r>
              <a:r>
                <a:rPr lang="de-DE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B02F36A0-FA52-4E3C-9EC4-6240CCB55D9B}"/>
                </a:ext>
              </a:extLst>
            </p:cNvPr>
            <p:cNvSpPr txBox="1"/>
            <p:nvPr/>
          </p:nvSpPr>
          <p:spPr>
            <a:xfrm rot="16200000">
              <a:off x="3162402" y="1099459"/>
              <a:ext cx="5517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1229 X</a:t>
              </a:r>
              <a:r>
                <a:rPr lang="de-DE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7353F56F-184A-435A-8918-25B790B676A2}"/>
                </a:ext>
              </a:extLst>
            </p:cNvPr>
            <p:cNvSpPr txBox="1"/>
            <p:nvPr/>
          </p:nvSpPr>
          <p:spPr>
            <a:xfrm rot="16200000">
              <a:off x="2387527" y="1101779"/>
              <a:ext cx="5517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1097 X</a:t>
              </a:r>
              <a:r>
                <a:rPr lang="de-DE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693076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82556316-5765-4610-9123-D21ECAECC027}"/>
              </a:ext>
            </a:extLst>
          </p:cNvPr>
          <p:cNvSpPr txBox="1"/>
          <p:nvPr/>
        </p:nvSpPr>
        <p:spPr>
          <a:xfrm flipH="1">
            <a:off x="66675" y="5265673"/>
            <a:ext cx="672465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GUX1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shows comparable transcription levels in the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tbl29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tbl29 max3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utants. </a:t>
            </a:r>
          </a:p>
          <a:p>
            <a:pPr algn="just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Quantitative real-time PCR analysis of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GUX1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gene expression in stem tissue normalized to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AtACTIN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Data are represented as means ± SD (n = 3 biological replicates). Different letters indicate significant differences (Tukey’s HSD test, p&lt;0.05).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613239F-5FB2-434D-AC64-4E8E562713E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1187" y="2911088"/>
            <a:ext cx="2689865" cy="23545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724968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4E43BF2-4D39-41D1-B8FD-C37871CCB0D9}"/>
              </a:ext>
            </a:extLst>
          </p:cNvPr>
          <p:cNvSpPr txBox="1"/>
          <p:nvPr/>
        </p:nvSpPr>
        <p:spPr>
          <a:xfrm flipH="1">
            <a:off x="185006" y="6348030"/>
            <a:ext cx="637454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Morphological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phenotype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gux1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 max3 gux1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tbl29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GUX1-OE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plants. </a:t>
            </a:r>
          </a:p>
          <a:p>
            <a:pPr algn="just"/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Representativ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image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6-week-old plants of the indicated genotypes. Bar = 10 cm.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5F44787-DDF7-4DB2-BF76-7E493F8889A3}"/>
              </a:ext>
            </a:extLst>
          </p:cNvPr>
          <p:cNvSpPr txBox="1"/>
          <p:nvPr/>
        </p:nvSpPr>
        <p:spPr>
          <a:xfrm flipH="1">
            <a:off x="1326864" y="5981840"/>
            <a:ext cx="6080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gux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C53248A-4026-4C8E-B6EA-BF42EB759D15}"/>
              </a:ext>
            </a:extLst>
          </p:cNvPr>
          <p:cNvSpPr txBox="1"/>
          <p:nvPr/>
        </p:nvSpPr>
        <p:spPr>
          <a:xfrm flipH="1">
            <a:off x="3052092" y="5981840"/>
            <a:ext cx="8708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max3 gux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A48BC5E-FF35-4380-9DC4-CA943D1ABD0A}"/>
              </a:ext>
            </a:extLst>
          </p:cNvPr>
          <p:cNvSpPr txBox="1"/>
          <p:nvPr/>
        </p:nvSpPr>
        <p:spPr>
          <a:xfrm flipH="1">
            <a:off x="4758864" y="5981840"/>
            <a:ext cx="11720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tbl29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r>
              <a:rPr lang="de-DE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GUX1-OE</a:t>
            </a:r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id="{D90EA4F9-4539-42A8-96E1-60E9D778D046}"/>
              </a:ext>
            </a:extLst>
          </p:cNvPr>
          <p:cNvGrpSpPr/>
          <p:nvPr/>
        </p:nvGrpSpPr>
        <p:grpSpPr>
          <a:xfrm>
            <a:off x="697628" y="2295064"/>
            <a:ext cx="5579467" cy="3660073"/>
            <a:chOff x="697628" y="2295064"/>
            <a:chExt cx="5579467" cy="3660073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721B7B77-B5F2-4F25-AFB2-CF13EFE9A4F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64" t="17447" r="4399" b="15744"/>
            <a:stretch/>
          </p:blipFill>
          <p:spPr>
            <a:xfrm rot="5400000">
              <a:off x="1657464" y="3208748"/>
              <a:ext cx="3660072" cy="1832704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1C97FEFA-986E-417C-9BD5-82D5374057E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30" t="16171" r="3333" b="17021"/>
            <a:stretch/>
          </p:blipFill>
          <p:spPr>
            <a:xfrm rot="5400000">
              <a:off x="-216069" y="3208762"/>
              <a:ext cx="3660072" cy="1832677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071DA8B5-4A3B-49C1-B506-412869A1879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37" t="14520" r="3628" b="19058"/>
            <a:stretch/>
          </p:blipFill>
          <p:spPr>
            <a:xfrm rot="5400000">
              <a:off x="3531383" y="3208376"/>
              <a:ext cx="3659024" cy="1832400"/>
            </a:xfrm>
            <a:prstGeom prst="rect">
              <a:avLst/>
            </a:prstGeom>
          </p:spPr>
        </p:pic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0BA4D55D-BE6F-489E-A1FB-0978F2AB6EC5}"/>
                </a:ext>
              </a:extLst>
            </p:cNvPr>
            <p:cNvCxnSpPr/>
            <p:nvPr/>
          </p:nvCxnSpPr>
          <p:spPr>
            <a:xfrm>
              <a:off x="6161331" y="5181314"/>
              <a:ext cx="0" cy="714375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2349135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70</Words>
  <Application>Microsoft Office PowerPoint</Application>
  <PresentationFormat>A4 Paper (210x297 mm)</PresentationFormat>
  <Paragraphs>5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少干 王</dc:creator>
  <cp:lastModifiedBy>少干 王</cp:lastModifiedBy>
  <cp:revision>452</cp:revision>
  <dcterms:created xsi:type="dcterms:W3CDTF">2025-06-20T14:02:55Z</dcterms:created>
  <dcterms:modified xsi:type="dcterms:W3CDTF">2026-06-11T08:10:04Z</dcterms:modified>
</cp:coreProperties>
</file>